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95E95-FEA1-4B91-B9D1-19D8CDA3576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A9A9FA-4EB4-43B6-A5EA-78FC4662AC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FE165-7633-43BF-9A47-8890CB952A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EBAA03-C617-4E96-B497-ED33FB2C062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0C8145-69B9-4CA9-B84F-EA782EC471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89445-5A33-48AF-8B03-C22E81BA31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C5DBAA-C58A-43A4-B6A0-9F0A136FF0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FD503A-99E1-4BAB-A5D6-68FB3B571F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1CFB0-3EAE-4872-BFEA-C4CEA76A3A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89155-C402-47D7-8E67-022BDF4B38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E83CCE-BAD3-40FE-96FF-D0BBE9D3DE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03A58-91DF-495E-84EC-C18696C800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AU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D03EB6-D4D4-461D-9680-389387B28E8D}" type="slidenum">
              <a:rPr b="0" lang="en-AU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62"/>
          <p:cNvSpPr/>
          <p:nvPr/>
        </p:nvSpPr>
        <p:spPr>
          <a:xfrm>
            <a:off x="571680" y="714240"/>
            <a:ext cx="50004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400" spc="-1" strike="noStrike">
                <a:solidFill>
                  <a:srgbClr val="000000"/>
                </a:solidFill>
                <a:latin typeface="Times New Roman"/>
              </a:rPr>
              <a:t>Figure A </a:t>
            </a:r>
            <a:r>
              <a:rPr b="0" lang="en-AU" sz="1400" spc="-1" strike="noStrike">
                <a:solidFill>
                  <a:srgbClr val="000000"/>
                </a:solidFill>
                <a:latin typeface="Times New Roman"/>
              </a:rPr>
              <a:t>(online only)  Flow diagram showing case recruitment, participation and follow up to the three year interview for the Prostate Cancer Care and Outcomes Study (PCOS)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Group 35"/>
          <p:cNvGrpSpPr/>
          <p:nvPr/>
        </p:nvGrpSpPr>
        <p:grpSpPr>
          <a:xfrm>
            <a:off x="857160" y="1687680"/>
            <a:ext cx="4643640" cy="6813720"/>
            <a:chOff x="857160" y="1687680"/>
            <a:chExt cx="4643640" cy="6813720"/>
          </a:xfrm>
        </p:grpSpPr>
        <p:sp>
          <p:nvSpPr>
            <p:cNvPr id="43" name="Text Box 5"/>
            <p:cNvSpPr/>
            <p:nvPr/>
          </p:nvSpPr>
          <p:spPr>
            <a:xfrm>
              <a:off x="907920" y="1687680"/>
              <a:ext cx="4592880" cy="246240"/>
            </a:xfrm>
            <a:prstGeom prst="rect">
              <a:avLst/>
            </a:prstGeom>
            <a:solidFill>
              <a:srgbClr val="eef9f4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otentially eligible cases (n=3195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Text Box 7"/>
            <p:cNvSpPr/>
            <p:nvPr/>
          </p:nvSpPr>
          <p:spPr>
            <a:xfrm>
              <a:off x="1500120" y="2071800"/>
              <a:ext cx="4000680" cy="70308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Doctor did not consent (n=537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Doctor refused all participation (n= 336 patients under eight doctors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Doctor refused consent (n=152 patients from 246 doctors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Consent from doctor pending at study close (n= 49 patients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Text Box 8"/>
            <p:cNvSpPr/>
            <p:nvPr/>
          </p:nvSpPr>
          <p:spPr>
            <a:xfrm>
              <a:off x="928440" y="2928960"/>
              <a:ext cx="457236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for whom doctor gave consent to contact (n= 2658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Text Box 9"/>
            <p:cNvSpPr/>
            <p:nvPr/>
          </p:nvSpPr>
          <p:spPr>
            <a:xfrm>
              <a:off x="857160" y="364320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who gave consent (n= 2031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Text Box 10"/>
            <p:cNvSpPr/>
            <p:nvPr/>
          </p:nvSpPr>
          <p:spPr>
            <a:xfrm>
              <a:off x="1500120" y="328968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Refused consent (n= 627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Text Box 14"/>
            <p:cNvSpPr/>
            <p:nvPr/>
          </p:nvSpPr>
          <p:spPr>
            <a:xfrm>
              <a:off x="857160" y="678672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interviewed at one year (n=1599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Text Box 15"/>
            <p:cNvSpPr/>
            <p:nvPr/>
          </p:nvSpPr>
          <p:spPr>
            <a:xfrm>
              <a:off x="857160" y="750096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interviewed at two years (n=1530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Text Box 16"/>
            <p:cNvSpPr/>
            <p:nvPr/>
          </p:nvSpPr>
          <p:spPr>
            <a:xfrm>
              <a:off x="857160" y="825516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interviewed at three years (n=1493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Text Box 18"/>
            <p:cNvSpPr/>
            <p:nvPr/>
          </p:nvSpPr>
          <p:spPr>
            <a:xfrm>
              <a:off x="1500120" y="571500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Advanced stage cancer (n= 232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52" name="AutoShape 25"/>
            <p:cNvCxnSpPr/>
            <p:nvPr/>
          </p:nvCxnSpPr>
          <p:spPr>
            <a:xfrm flipH="1">
              <a:off x="1213560" y="1928880"/>
              <a:ext cx="1080" cy="10008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3" name="Text Box 43"/>
            <p:cNvSpPr/>
            <p:nvPr/>
          </p:nvSpPr>
          <p:spPr>
            <a:xfrm>
              <a:off x="857160" y="5357880"/>
              <a:ext cx="4643640" cy="246240"/>
            </a:xfrm>
            <a:prstGeom prst="rect">
              <a:avLst/>
            </a:prstGeom>
            <a:solidFill>
              <a:srgbClr val="eef9f4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for whom clinical records were obtained (n=1874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Text Box 47"/>
            <p:cNvSpPr/>
            <p:nvPr/>
          </p:nvSpPr>
          <p:spPr>
            <a:xfrm>
              <a:off x="857160" y="607212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with localised prostate cancer (n= 1642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Text Box 50"/>
            <p:cNvSpPr/>
            <p:nvPr/>
          </p:nvSpPr>
          <p:spPr>
            <a:xfrm>
              <a:off x="1500120" y="400068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Withdrew or lost to follow up  before baseline (n= 36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Text Box 52"/>
            <p:cNvSpPr/>
            <p:nvPr/>
          </p:nvSpPr>
          <p:spPr>
            <a:xfrm>
              <a:off x="1500120" y="4716360"/>
              <a:ext cx="4000680" cy="55080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Cancer stage unknown (n=121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 refused consent to medical notes (n=80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Medical notes could not be found (n=41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Text Box 54"/>
            <p:cNvSpPr/>
            <p:nvPr/>
          </p:nvSpPr>
          <p:spPr>
            <a:xfrm>
              <a:off x="1500120" y="642960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Lost to follow-up (n=43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Text Box 60"/>
            <p:cNvSpPr/>
            <p:nvPr/>
          </p:nvSpPr>
          <p:spPr>
            <a:xfrm>
              <a:off x="857160" y="4357800"/>
              <a:ext cx="4643640" cy="246240"/>
            </a:xfrm>
            <a:prstGeom prst="rect">
              <a:avLst/>
            </a:prstGeom>
            <a:solidFill>
              <a:srgbClr val="eef9f4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Patients assessed at baseline (n= 1995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Text Box 54"/>
            <p:cNvSpPr/>
            <p:nvPr/>
          </p:nvSpPr>
          <p:spPr>
            <a:xfrm>
              <a:off x="1500120" y="785844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Lost to follow-up (n=37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Text Box 54"/>
            <p:cNvSpPr/>
            <p:nvPr/>
          </p:nvSpPr>
          <p:spPr>
            <a:xfrm>
              <a:off x="1500120" y="7143840"/>
              <a:ext cx="4000680" cy="246240"/>
            </a:xfrm>
            <a:prstGeom prst="rect">
              <a:avLst/>
            </a:prstGeom>
            <a:solidFill>
              <a:srgbClr val="f2f2f2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AU" sz="1000" spc="-1" strike="noStrike">
                  <a:solidFill>
                    <a:srgbClr val="000000"/>
                  </a:solidFill>
                  <a:latin typeface="Arial"/>
                </a:rPr>
                <a:t>Lost to follow-up (n=69)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cxnSp>
          <p:nvCxnSpPr>
            <p:cNvPr id="61" name="AutoShape 25"/>
            <p:cNvCxnSpPr/>
            <p:nvPr/>
          </p:nvCxnSpPr>
          <p:spPr>
            <a:xfrm flipH="1">
              <a:off x="1212120" y="778680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2" name="AutoShape 25"/>
            <p:cNvCxnSpPr/>
            <p:nvPr/>
          </p:nvCxnSpPr>
          <p:spPr>
            <a:xfrm flipH="1">
              <a:off x="1213920" y="707256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3" name="AutoShape 25"/>
            <p:cNvCxnSpPr/>
            <p:nvPr/>
          </p:nvCxnSpPr>
          <p:spPr>
            <a:xfrm flipH="1">
              <a:off x="1213920" y="635796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4" name="AutoShape 25"/>
            <p:cNvCxnSpPr/>
            <p:nvPr/>
          </p:nvCxnSpPr>
          <p:spPr>
            <a:xfrm flipH="1">
              <a:off x="1213920" y="564372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5" name="AutoShape 25"/>
            <p:cNvCxnSpPr/>
            <p:nvPr/>
          </p:nvCxnSpPr>
          <p:spPr>
            <a:xfrm flipH="1">
              <a:off x="1212120" y="4643640"/>
              <a:ext cx="2160" cy="716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6" name="AutoShape 25"/>
            <p:cNvCxnSpPr/>
            <p:nvPr/>
          </p:nvCxnSpPr>
          <p:spPr>
            <a:xfrm flipH="1">
              <a:off x="1213920" y="392904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7" name="AutoShape 25"/>
            <p:cNvCxnSpPr/>
            <p:nvPr/>
          </p:nvCxnSpPr>
          <p:spPr>
            <a:xfrm flipH="1">
              <a:off x="1213920" y="3214800"/>
              <a:ext cx="2160" cy="42912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8" name="AutoShape 25"/>
            <p:cNvCxnSpPr/>
            <p:nvPr/>
          </p:nvCxnSpPr>
          <p:spPr>
            <a:xfrm>
              <a:off x="1213920" y="235728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9" name="AutoShape 25"/>
            <p:cNvCxnSpPr/>
            <p:nvPr/>
          </p:nvCxnSpPr>
          <p:spPr>
            <a:xfrm>
              <a:off x="1213920" y="342900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0" name="AutoShape 25"/>
            <p:cNvCxnSpPr/>
            <p:nvPr/>
          </p:nvCxnSpPr>
          <p:spPr>
            <a:xfrm>
              <a:off x="1213920" y="414360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1" name="AutoShape 25"/>
            <p:cNvCxnSpPr/>
            <p:nvPr/>
          </p:nvCxnSpPr>
          <p:spPr>
            <a:xfrm>
              <a:off x="1213920" y="492912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2" name="AutoShape 25"/>
            <p:cNvCxnSpPr/>
            <p:nvPr/>
          </p:nvCxnSpPr>
          <p:spPr>
            <a:xfrm>
              <a:off x="1213920" y="585792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3" name="AutoShape 25"/>
            <p:cNvCxnSpPr/>
            <p:nvPr/>
          </p:nvCxnSpPr>
          <p:spPr>
            <a:xfrm>
              <a:off x="1213920" y="657252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4" name="AutoShape 25"/>
            <p:cNvCxnSpPr/>
            <p:nvPr/>
          </p:nvCxnSpPr>
          <p:spPr>
            <a:xfrm>
              <a:off x="1213920" y="728676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5" name="AutoShape 25"/>
            <p:cNvCxnSpPr/>
            <p:nvPr/>
          </p:nvCxnSpPr>
          <p:spPr>
            <a:xfrm>
              <a:off x="1213920" y="8001000"/>
              <a:ext cx="286200" cy="2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4T02:44:43Z</dcterms:created>
  <dc:creator>installw2k</dc:creator>
  <dc:description/>
  <dc:language>en-US</dc:language>
  <cp:lastModifiedBy>Baylor College of Medicine</cp:lastModifiedBy>
  <cp:lastPrinted>2009-09-11T05:57:51Z</cp:lastPrinted>
  <dcterms:modified xsi:type="dcterms:W3CDTF">2011-11-11T16:49:07Z</dcterms:modified>
  <cp:revision>34</cp:revision>
  <dc:subject/>
  <dc:title>PowerPoint Presentation</dc:title>
</cp:coreProperties>
</file>